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3" r:id="rId3"/>
  </p:sldIdLst>
  <p:sldSz cx="6858000" cy="9906000" type="A4"/>
  <p:notesSz cx="6858000" cy="9144000"/>
  <p:custDataLst>
    <p:tags r:id="rId7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04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1608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 hasCustomPrompt="1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GSE181919_progeny_tissuetype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54405" y="1668145"/>
            <a:ext cx="4686300" cy="250634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4538028"/>
            <a:ext cx="68580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. Oncogenic pathway activity in epithelial cells of the GSE181919 dataset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eatmap shows differences in oncogenic pathway activity based on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ROGENy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scores for epithelial cells from normal tissue (NL), leukoplakia (LP) and cancer (CA) of males.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GQ2OGFkOTMxOTRjMjAwNGJjNzU4YzIzNGY2NWUwNzUifQ=="/>
</p:tagLst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2</Words>
  <Application>WPS 演示</Application>
  <PresentationFormat>A4-Papier (210 x 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微软雅黑</vt:lpstr>
      <vt:lpstr>Calibri</vt:lpstr>
      <vt:lpstr>Arial Unicode MS</vt:lpstr>
      <vt:lpstr>Offic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eß, Jochen</dc:creator>
  <cp:lastModifiedBy>韩蕊</cp:lastModifiedBy>
  <cp:revision>37</cp:revision>
  <dcterms:created xsi:type="dcterms:W3CDTF">2024-09-10T14:28:00Z</dcterms:created>
  <dcterms:modified xsi:type="dcterms:W3CDTF">2025-07-21T02:03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6E60A1633A442EAA0CE53EB4377AEE4_13</vt:lpwstr>
  </property>
  <property fmtid="{D5CDD505-2E9C-101B-9397-08002B2CF9AE}" pid="3" name="KSOProductBuildVer">
    <vt:lpwstr>2052-12.1.0.21915</vt:lpwstr>
  </property>
</Properties>
</file>